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93BF6D-19BB-4700-93E6-562EB21A6C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FC09D-D597-47A8-935A-6423715243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1D68D7-32DF-4C68-849A-19E3CA4786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5198BF-A9FA-4D5F-A381-D5F9D2F5912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B12F16-125A-41F7-B632-B7826727A8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E4F33B-4609-4F86-875F-9E21C95BF7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AEDA8-645E-4B03-ABCA-4492F6AB6F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2EBB9E-5905-4633-8202-09144EF1CB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B80B6-DED8-487D-B3FE-175284D6E0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EDB340-9E36-4337-A9CC-024C38A2CB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E91023-C6F9-49BE-948D-7216A251ED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B3A1B-FCA0-4776-86A4-8115C8B7CF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46EFC2-ADE6-48F4-B5B5-F48A68A1783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0360" y="762120"/>
          <a:ext cx="6669360" cy="8789760"/>
        </p:xfrm>
        <a:graphic>
          <a:graphicData uri="http://schemas.openxmlformats.org/drawingml/2006/table">
            <a:tbl>
              <a:tblPr/>
              <a:tblGrid>
                <a:gridCol w="449280"/>
                <a:gridCol w="258840"/>
                <a:gridCol w="266760"/>
                <a:gridCol w="298440"/>
                <a:gridCol w="299880"/>
                <a:gridCol w="300240"/>
                <a:gridCol w="374760"/>
                <a:gridCol w="374400"/>
                <a:gridCol w="374760"/>
                <a:gridCol w="431640"/>
                <a:gridCol w="457200"/>
                <a:gridCol w="533520"/>
                <a:gridCol w="450720"/>
                <a:gridCol w="900360"/>
                <a:gridCol w="898560"/>
              </a:tblGrid>
              <a:tr h="30636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orm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J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J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ll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ll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um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Hes1/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Cleaved N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pErk1/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,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08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2160" marR="21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920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Canc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J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J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ll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ll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um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Hes1/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Cleaved N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pErk1/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# of positive nodes)/(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# of nod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Dissected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0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ER/PR/Her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/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+/+/+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/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+/-/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0/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+/+/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/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+/+/+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/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/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40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0/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-/-/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/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+/+/+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372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0/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-/-/+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/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+/+/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/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+/+/+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/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+/+/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212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14"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0/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2/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+/-/+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/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6/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-/+/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0/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6/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0/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1/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5/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9/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+/+/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/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-/-/N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  <a:tc>
                  <a:txBody>
                    <a:bodyPr lIns="2160" rIns="2160" tIns="21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5060880" y="1171440"/>
          <a:ext cx="1674720" cy="1346400"/>
        </p:xfrm>
        <a:graphic>
          <a:graphicData uri="http://schemas.openxmlformats.org/drawingml/2006/table">
            <a:tbl>
              <a:tblPr/>
              <a:tblGrid>
                <a:gridCol w="509760"/>
                <a:gridCol w="1164960"/>
              </a:tblGrid>
              <a:tr h="1922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+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cc"/>
                    </a:solidFill>
                  </a:tcPr>
                </a:tc>
              </a:tr>
              <a:tr h="1922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+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ff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+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</a:tr>
              <a:tr h="19188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4+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3300"/>
                    </a:solidFill>
                  </a:tcPr>
                </a:tc>
              </a:tr>
              <a:tr h="1922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D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00"/>
                    </a:solidFill>
                  </a:tcPr>
                </a:tc>
              </a:tr>
              <a:tr h="19188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e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339966"/>
                    </a:solidFill>
                  </a:tcPr>
                </a:tc>
              </a:tr>
              <a:tr h="1922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2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ot Availab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Box 42"/>
          <p:cNvSpPr/>
          <p:nvPr/>
        </p:nvSpPr>
        <p:spPr>
          <a:xfrm>
            <a:off x="341280" y="228600"/>
            <a:ext cx="2873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Revised Additiona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le 3: Fig.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Suruchi</dc:creator>
  <dc:description/>
  <dc:language>en-US</dc:language>
  <cp:lastModifiedBy>MAMMY</cp:lastModifiedBy>
  <dcterms:modified xsi:type="dcterms:W3CDTF">2009-11-13T14:53:34Z</dcterms:modified>
  <cp:revision>320</cp:revision>
  <dc:subject/>
  <dc:title>Slide 1</dc:title>
</cp:coreProperties>
</file>